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>
      <p:cViewPr>
        <p:scale>
          <a:sx n="100" d="100"/>
          <a:sy n="100" d="100"/>
        </p:scale>
        <p:origin x="990" y="3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AE807F2-6711-4FD0-BCA9-B243289203F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0413913A-3AE0-4074-B21E-70CB7049898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586D1E2-12C3-4715-A8E0-BC31E2330A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70038-9241-413D-87C5-BC83B6D23BB7}" type="datetimeFigureOut">
              <a:rPr lang="ko-KR" altLang="en-US" smtClean="0"/>
              <a:t>2025-05-2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A59307B-9D3A-4FC5-841C-4ADD434525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27B9F39-9823-4C25-8EAA-50ED734289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74B59-AF9B-4BA6-8673-7AEB0B7247F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916792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3D20B7F-BE4F-4A69-8946-0D4BA37246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2AAAD014-CDF1-4EBD-82E1-B52B4D11C9E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F2DADA4-11A6-4E69-8DCF-E0288F6F78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70038-9241-413D-87C5-BC83B6D23BB7}" type="datetimeFigureOut">
              <a:rPr lang="ko-KR" altLang="en-US" smtClean="0"/>
              <a:t>2025-05-2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4F69FE2-AB13-4014-844B-01F23755F6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BA7D57C-8A40-4B12-9B37-EF56C10C94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74B59-AF9B-4BA6-8673-7AEB0B7247F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134323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09A0F629-37A6-4DC8-8A1B-FDFB2D7B813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9BC138EC-3D21-4D0C-8720-4F7327FEAE8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6DA5AF1-B754-47B4-B8D6-2F96357C57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70038-9241-413D-87C5-BC83B6D23BB7}" type="datetimeFigureOut">
              <a:rPr lang="ko-KR" altLang="en-US" smtClean="0"/>
              <a:t>2025-05-2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339587F-DCA2-413A-9989-303C791343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0501D81-A911-4936-86A3-85D9EFE00E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74B59-AF9B-4BA6-8673-7AEB0B7247F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660893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58BA5E2-6B86-49C1-8551-7C1560F469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73C6DEEB-9A9B-423E-8779-CB70967EF4E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DE41A87-D34F-4E5D-9678-61308F2B31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70038-9241-413D-87C5-BC83B6D23BB7}" type="datetimeFigureOut">
              <a:rPr lang="ko-KR" altLang="en-US" smtClean="0"/>
              <a:t>2025-05-2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18B3772-C11B-45B8-806B-0F1FDDFCF5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079A8E1-E440-4D3B-A5BB-AD2197921B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74B59-AF9B-4BA6-8673-7AEB0B7247F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650600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5B7B05A-20A3-494D-8F83-9289A39809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356D65E6-9C55-41BC-8ADD-8646805555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730A81E-354F-4D04-96B2-2279A9DB1D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70038-9241-413D-87C5-BC83B6D23BB7}" type="datetimeFigureOut">
              <a:rPr lang="ko-KR" altLang="en-US" smtClean="0"/>
              <a:t>2025-05-2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192D8D1-EC1F-4506-99C0-0DFCBB49DB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DE7F9A6-C1C0-41E6-863B-6B60EBFC83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74B59-AF9B-4BA6-8673-7AEB0B7247F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47093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2510890-D991-4CB7-851D-44DF59F6DD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E273D375-D6A0-4564-AECD-E8325250E48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E8391892-E3D5-44C9-BB58-E503B2B408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BA0BDFF-2E45-4DF8-A6F1-6295DA160B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70038-9241-413D-87C5-BC83B6D23BB7}" type="datetimeFigureOut">
              <a:rPr lang="ko-KR" altLang="en-US" smtClean="0"/>
              <a:t>2025-05-2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B5890CD9-0D15-4894-8574-033399275D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119DC73-E2F5-4014-B247-378362A173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74B59-AF9B-4BA6-8673-7AEB0B7247F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269960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63B7638-65FF-4F58-AA1B-3A3C543508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F68303F5-3664-4E33-B5A9-74FA081C17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ED4129BE-980E-4D97-BF06-9C1A012F8F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33D98E6D-BDC5-4C04-AE66-D41C1B767E8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9668C525-FD54-4D7C-B326-BAE23B4FC95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D5706558-7670-4B26-80DA-06DE8DD76E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70038-9241-413D-87C5-BC83B6D23BB7}" type="datetimeFigureOut">
              <a:rPr lang="ko-KR" altLang="en-US" smtClean="0"/>
              <a:t>2025-05-22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87D5A28F-77FC-448B-B5AE-7A023596B7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74E1F691-82B0-4B10-A8D8-45DD22AB35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74B59-AF9B-4BA6-8673-7AEB0B7247F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876835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E02E40A-B2BF-4D54-B0DA-D5CA9FC350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9C13237C-E396-4C47-8639-3DB384884B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70038-9241-413D-87C5-BC83B6D23BB7}" type="datetimeFigureOut">
              <a:rPr lang="ko-KR" altLang="en-US" smtClean="0"/>
              <a:t>2025-05-22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232E290E-8C47-4D41-8302-34004F77C4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C8283C43-AF7D-4102-868B-F0E0430D99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74B59-AF9B-4BA6-8673-7AEB0B7247F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831193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D8736C4C-A224-4C88-A791-459F6E24BB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70038-9241-413D-87C5-BC83B6D23BB7}" type="datetimeFigureOut">
              <a:rPr lang="ko-KR" altLang="en-US" smtClean="0"/>
              <a:t>2025-05-22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940E978F-7422-47F4-A144-A36627B608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21250EB9-004B-4BE2-BCEF-7D0DF482AF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74B59-AF9B-4BA6-8673-7AEB0B7247F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777315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3003F17-2EBC-4DFA-AAB6-EA45AABA6D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5083D430-CCFD-4CF5-BAEC-7457660CB90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DA8DDE07-2680-489C-9574-7FF1C42C7D6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3E0912AE-E66F-4C71-BC3F-BDB614FAE1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70038-9241-413D-87C5-BC83B6D23BB7}" type="datetimeFigureOut">
              <a:rPr lang="ko-KR" altLang="en-US" smtClean="0"/>
              <a:t>2025-05-2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F32BC761-D69A-4D15-9BAB-18AD7EC269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2C110290-C251-4C5A-96A8-E95642AFA1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74B59-AF9B-4BA6-8673-7AEB0B7247F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364331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17D7D7C-C318-467F-A4AF-D7F24EB325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CE93BD68-73A2-41A4-90DD-8A011DF01EA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F8BCC79D-49CC-4D20-B802-2001BD089C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BE71206E-B6FF-4FE8-B01E-9D3EAE8D10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870038-9241-413D-87C5-BC83B6D23BB7}" type="datetimeFigureOut">
              <a:rPr lang="ko-KR" altLang="en-US" smtClean="0"/>
              <a:t>2025-05-2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FC437681-B234-47D2-B733-DB32501D11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9F3711A-AFA5-49DD-9004-EC551DFF6D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974B59-AF9B-4BA6-8673-7AEB0B7247F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89751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CCE9221E-32BE-48AC-8846-84D0398D60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AB95BD6-8386-47E1-9731-0F1B6F68EC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2957654-5367-4499-A65D-41E8CE659C7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870038-9241-413D-87C5-BC83B6D23BB7}" type="datetimeFigureOut">
              <a:rPr lang="ko-KR" altLang="en-US" smtClean="0"/>
              <a:t>2025-05-2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1DF5997-05A5-45CE-B65D-B3CA54AA63D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DCF8B66-BB5D-486C-9DDE-53DF0CEE688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974B59-AF9B-4BA6-8673-7AEB0B7247F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957291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7" descr="A screenshot of a map&#10;&#10;Description automatically generated">
            <a:extLst>
              <a:ext uri="{FF2B5EF4-FFF2-40B4-BE49-F238E27FC236}">
                <a16:creationId xmlns:a16="http://schemas.microsoft.com/office/drawing/2014/main" id="{F0387F2D-E669-4DF0-99FE-0ECC6419499B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2126512" y="192451"/>
            <a:ext cx="4751073" cy="4443344"/>
          </a:xfrm>
          <a:prstGeom prst="rect">
            <a:avLst/>
          </a:prstGeom>
        </p:spPr>
      </p:pic>
      <p:sp>
        <p:nvSpPr>
          <p:cNvPr id="5" name="Rectangle 18">
            <a:extLst>
              <a:ext uri="{FF2B5EF4-FFF2-40B4-BE49-F238E27FC236}">
                <a16:creationId xmlns:a16="http://schemas.microsoft.com/office/drawing/2014/main" id="{B9953A99-301D-49C5-9CD7-CC7E95E6604D}"/>
              </a:ext>
            </a:extLst>
          </p:cNvPr>
          <p:cNvSpPr/>
          <p:nvPr/>
        </p:nvSpPr>
        <p:spPr>
          <a:xfrm>
            <a:off x="2905200" y="3749818"/>
            <a:ext cx="108992" cy="126000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/>
          </a:p>
        </p:txBody>
      </p:sp>
      <p:pic>
        <p:nvPicPr>
          <p:cNvPr id="8" name="Picture 21">
            <a:extLst>
              <a:ext uri="{FF2B5EF4-FFF2-40B4-BE49-F238E27FC236}">
                <a16:creationId xmlns:a16="http://schemas.microsoft.com/office/drawing/2014/main" id="{2758AE1E-DC3E-432D-8725-0A3BD1F59A5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72827" y="87519"/>
            <a:ext cx="3821771" cy="4699343"/>
          </a:xfrm>
          <a:prstGeom prst="rect">
            <a:avLst/>
          </a:prstGeom>
        </p:spPr>
      </p:pic>
      <p:cxnSp>
        <p:nvCxnSpPr>
          <p:cNvPr id="10" name="Straight Arrow Connector 23">
            <a:extLst>
              <a:ext uri="{FF2B5EF4-FFF2-40B4-BE49-F238E27FC236}">
                <a16:creationId xmlns:a16="http://schemas.microsoft.com/office/drawing/2014/main" id="{37303CE3-9D19-4D21-90C6-B3F6AACB822A}"/>
              </a:ext>
            </a:extLst>
          </p:cNvPr>
          <p:cNvCxnSpPr>
            <a:cxnSpLocks/>
          </p:cNvCxnSpPr>
          <p:nvPr/>
        </p:nvCxnSpPr>
        <p:spPr>
          <a:xfrm>
            <a:off x="9024425" y="3183485"/>
            <a:ext cx="507557" cy="0"/>
          </a:xfrm>
          <a:prstGeom prst="straightConnector1">
            <a:avLst/>
          </a:prstGeom>
          <a:ln w="254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E31D01EE-058D-45F1-8C87-6286DBFED91E}"/>
              </a:ext>
            </a:extLst>
          </p:cNvPr>
          <p:cNvSpPr txBox="1"/>
          <p:nvPr/>
        </p:nvSpPr>
        <p:spPr>
          <a:xfrm>
            <a:off x="9442919" y="2921168"/>
            <a:ext cx="250335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ko-KR" altLang="en-US" sz="2400" dirty="0"/>
              <a:t> </a:t>
            </a:r>
            <a:r>
              <a:rPr lang="en-US" altLang="ko-KR" dirty="0"/>
              <a:t>MOCS2B</a:t>
            </a:r>
            <a:endParaRPr lang="en-US" dirty="0"/>
          </a:p>
          <a:p>
            <a:r>
              <a:rPr lang="en-US" altLang="ko-KR" dirty="0"/>
              <a:t> (NP_004522.1)</a:t>
            </a:r>
            <a:r>
              <a:rPr lang="en-US" dirty="0"/>
              <a:t>  </a:t>
            </a:r>
          </a:p>
          <a:p>
            <a:r>
              <a:rPr lang="en-US" dirty="0"/>
              <a:t> p.Leu19Phe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671197E-C16F-4EC6-B01D-91467437FCD5}"/>
              </a:ext>
            </a:extLst>
          </p:cNvPr>
          <p:cNvSpPr txBox="1"/>
          <p:nvPr/>
        </p:nvSpPr>
        <p:spPr>
          <a:xfrm>
            <a:off x="957927" y="3639632"/>
            <a:ext cx="1750800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dirty="0"/>
              <a:t> </a:t>
            </a:r>
            <a:r>
              <a:rPr lang="en-US" altLang="ko-KR" dirty="0"/>
              <a:t>MOCS2A</a:t>
            </a:r>
          </a:p>
          <a:p>
            <a:r>
              <a:rPr lang="en-US" dirty="0"/>
              <a:t> (NP_789776.1)</a:t>
            </a:r>
          </a:p>
          <a:p>
            <a:r>
              <a:rPr lang="en-US" dirty="0"/>
              <a:t> p.Ile82Phe</a:t>
            </a:r>
          </a:p>
        </p:txBody>
      </p:sp>
      <p:sp>
        <p:nvSpPr>
          <p:cNvPr id="18" name="직사각형 17">
            <a:extLst>
              <a:ext uri="{FF2B5EF4-FFF2-40B4-BE49-F238E27FC236}">
                <a16:creationId xmlns:a16="http://schemas.microsoft.com/office/drawing/2014/main" id="{A7AB88D5-1F3A-463C-8ACF-F9F0E5D78657}"/>
              </a:ext>
            </a:extLst>
          </p:cNvPr>
          <p:cNvSpPr/>
          <p:nvPr/>
        </p:nvSpPr>
        <p:spPr>
          <a:xfrm>
            <a:off x="1326102" y="5513981"/>
            <a:ext cx="110934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dirty="0"/>
              <a:t>Supplementary Figure 1. MOCS2 organization and causal mutant location by different isoforms</a:t>
            </a:r>
            <a:endParaRPr lang="ko-KR" altLang="en-US" dirty="0"/>
          </a:p>
        </p:txBody>
      </p:sp>
      <p:sp>
        <p:nvSpPr>
          <p:cNvPr id="12" name="Rectangle 18">
            <a:extLst>
              <a:ext uri="{FF2B5EF4-FFF2-40B4-BE49-F238E27FC236}">
                <a16:creationId xmlns:a16="http://schemas.microsoft.com/office/drawing/2014/main" id="{B9953A99-301D-49C5-9CD7-CC7E95E6604D}"/>
              </a:ext>
            </a:extLst>
          </p:cNvPr>
          <p:cNvSpPr/>
          <p:nvPr/>
        </p:nvSpPr>
        <p:spPr>
          <a:xfrm>
            <a:off x="8809200" y="3114000"/>
            <a:ext cx="108000" cy="122400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/>
          </a:p>
        </p:txBody>
      </p:sp>
      <p:cxnSp>
        <p:nvCxnSpPr>
          <p:cNvPr id="19" name="Straight Arrow Connector 23">
            <a:extLst>
              <a:ext uri="{FF2B5EF4-FFF2-40B4-BE49-F238E27FC236}">
                <a16:creationId xmlns:a16="http://schemas.microsoft.com/office/drawing/2014/main" id="{37303CE3-9D19-4D21-90C6-B3F6AACB822A}"/>
              </a:ext>
            </a:extLst>
          </p:cNvPr>
          <p:cNvCxnSpPr>
            <a:cxnSpLocks/>
          </p:cNvCxnSpPr>
          <p:nvPr/>
        </p:nvCxnSpPr>
        <p:spPr>
          <a:xfrm flipH="1" flipV="1">
            <a:off x="2269159" y="3805403"/>
            <a:ext cx="507557" cy="2174"/>
          </a:xfrm>
          <a:prstGeom prst="straightConnector1">
            <a:avLst/>
          </a:prstGeom>
          <a:ln w="254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994022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37</Words>
  <Application>Microsoft Office PowerPoint</Application>
  <PresentationFormat>Širokoúhlá obrazovka</PresentationFormat>
  <Paragraphs>7</Paragraphs>
  <Slides>1</Slides>
  <Notes>0</Notes>
  <HiddenSlides>0</HiddenSlides>
  <MMClips>0</MMClips>
  <ScaleCrop>false</ScaleCrop>
  <HeadingPairs>
    <vt:vector size="6" baseType="variant">
      <vt:variant>
        <vt:lpstr>Použitá písma</vt:lpstr>
      </vt:variant>
      <vt:variant>
        <vt:i4>2</vt:i4>
      </vt:variant>
      <vt:variant>
        <vt:lpstr>Motiv</vt:lpstr>
      </vt:variant>
      <vt:variant>
        <vt:i4>1</vt:i4>
      </vt:variant>
      <vt:variant>
        <vt:lpstr>Nadpisy snímků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rezentace aplikac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ontan</dc:creator>
  <cp:lastModifiedBy>Pavelcová Kateřina</cp:lastModifiedBy>
  <cp:revision>5</cp:revision>
  <dcterms:created xsi:type="dcterms:W3CDTF">2024-02-14T03:47:31Z</dcterms:created>
  <dcterms:modified xsi:type="dcterms:W3CDTF">2025-05-22T11:45:38Z</dcterms:modified>
</cp:coreProperties>
</file>